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0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呼吸器内科外来CRDr" initials="MSOffice" lastIdx="1" clrIdx="0">
    <p:extLst>
      <p:ext uri="{19B8F6BF-5375-455C-9EA6-DF929625EA0E}">
        <p15:presenceInfo xmlns:p15="http://schemas.microsoft.com/office/powerpoint/2012/main" userId="呼吸器内科外来CRD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0457" autoAdjust="0"/>
    <p:restoredTop sz="85526" autoAdjust="0"/>
  </p:normalViewPr>
  <p:slideViewPr>
    <p:cSldViewPr snapToGrid="0">
      <p:cViewPr varScale="1">
        <p:scale>
          <a:sx n="93" d="100"/>
          <a:sy n="93" d="100"/>
        </p:scale>
        <p:origin x="954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BEFD2DA-D9FF-4D84-AFE2-25B00794E520}" type="datetimeFigureOut">
              <a:rPr kumimoji="1" lang="ja-JP" altLang="en-US" smtClean="0"/>
              <a:t>2019/2/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0887B98-1575-49B4-AC89-863411D57A7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21669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887B98-1575-49B4-AC89-863411D57A72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68045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E1010E-8752-4AC8-A287-345A9EDA44EB}" type="datetimeFigureOut">
              <a:rPr kumimoji="1" lang="ja-JP" altLang="en-US" smtClean="0"/>
              <a:t>2019/2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7BD69-B1B5-459D-AB89-22F4C72EB4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64858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E1010E-8752-4AC8-A287-345A9EDA44EB}" type="datetimeFigureOut">
              <a:rPr kumimoji="1" lang="ja-JP" altLang="en-US" smtClean="0"/>
              <a:t>2019/2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7BD69-B1B5-459D-AB89-22F4C72EB4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736344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E1010E-8752-4AC8-A287-345A9EDA44EB}" type="datetimeFigureOut">
              <a:rPr kumimoji="1" lang="ja-JP" altLang="en-US" smtClean="0"/>
              <a:t>2019/2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7BD69-B1B5-459D-AB89-22F4C72EB4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244489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E1010E-8752-4AC8-A287-345A9EDA44EB}" type="datetimeFigureOut">
              <a:rPr kumimoji="1" lang="ja-JP" altLang="en-US" smtClean="0"/>
              <a:t>2019/2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7BD69-B1B5-459D-AB89-22F4C72EB4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98316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E1010E-8752-4AC8-A287-345A9EDA44EB}" type="datetimeFigureOut">
              <a:rPr kumimoji="1" lang="ja-JP" altLang="en-US" smtClean="0"/>
              <a:t>2019/2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7BD69-B1B5-459D-AB89-22F4C72EB4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15637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E1010E-8752-4AC8-A287-345A9EDA44EB}" type="datetimeFigureOut">
              <a:rPr kumimoji="1" lang="ja-JP" altLang="en-US" smtClean="0"/>
              <a:t>2019/2/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7BD69-B1B5-459D-AB89-22F4C72EB4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26802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E1010E-8752-4AC8-A287-345A9EDA44EB}" type="datetimeFigureOut">
              <a:rPr kumimoji="1" lang="ja-JP" altLang="en-US" smtClean="0"/>
              <a:t>2019/2/3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7BD69-B1B5-459D-AB89-22F4C72EB4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4680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E1010E-8752-4AC8-A287-345A9EDA44EB}" type="datetimeFigureOut">
              <a:rPr kumimoji="1" lang="ja-JP" altLang="en-US" smtClean="0"/>
              <a:t>2019/2/3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7BD69-B1B5-459D-AB89-22F4C72EB4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77614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E1010E-8752-4AC8-A287-345A9EDA44EB}" type="datetimeFigureOut">
              <a:rPr kumimoji="1" lang="ja-JP" altLang="en-US" smtClean="0"/>
              <a:t>2019/2/3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7BD69-B1B5-459D-AB89-22F4C72EB4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685544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E1010E-8752-4AC8-A287-345A9EDA44EB}" type="datetimeFigureOut">
              <a:rPr kumimoji="1" lang="ja-JP" altLang="en-US" smtClean="0"/>
              <a:t>2019/2/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7BD69-B1B5-459D-AB89-22F4C72EB4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957868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E1010E-8752-4AC8-A287-345A9EDA44EB}" type="datetimeFigureOut">
              <a:rPr kumimoji="1" lang="ja-JP" altLang="en-US" smtClean="0"/>
              <a:t>2019/2/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C7BD69-B1B5-459D-AB89-22F4C72EB4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53495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E1010E-8752-4AC8-A287-345A9EDA44EB}" type="datetimeFigureOut">
              <a:rPr kumimoji="1" lang="ja-JP" altLang="en-US" smtClean="0"/>
              <a:t>2019/2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C7BD69-B1B5-459D-AB89-22F4C72EB41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954267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40035" y="1677662"/>
            <a:ext cx="5991225" cy="4800600"/>
          </a:xfrm>
          <a:prstGeom prst="rect">
            <a:avLst/>
          </a:prstGeom>
        </p:spPr>
      </p:pic>
      <p:pic>
        <p:nvPicPr>
          <p:cNvPr id="15" name="図 1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8810" y="1677662"/>
            <a:ext cx="5991225" cy="4800600"/>
          </a:xfrm>
          <a:prstGeom prst="rect">
            <a:avLst/>
          </a:prstGeom>
        </p:spPr>
      </p:pic>
      <p:sp>
        <p:nvSpPr>
          <p:cNvPr id="4" name="テキスト ボックス 3"/>
          <p:cNvSpPr txBox="1"/>
          <p:nvPr/>
        </p:nvSpPr>
        <p:spPr>
          <a:xfrm>
            <a:off x="-38826" y="6012981"/>
            <a:ext cx="611638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/>
              <a:t>No. at Risk </a:t>
            </a:r>
          </a:p>
          <a:p>
            <a:r>
              <a:rPr lang="en-US" altLang="ja-JP" sz="1200" dirty="0"/>
              <a:t>Without IP     60      45        24       12        5         3          1         1         1         0         0         0         0                                         </a:t>
            </a:r>
          </a:p>
          <a:p>
            <a:r>
              <a:rPr lang="en-US" altLang="ja-JP" sz="1200" dirty="0"/>
              <a:t>With IP           27      19          8         3         2         2          2         2         1         1         1         0         0                                      </a:t>
            </a:r>
            <a:endParaRPr lang="en-US" altLang="ja-JP" sz="1400" dirty="0"/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3056A13C-3A85-49CE-8B90-A5B9DAB3974C}"/>
              </a:ext>
            </a:extLst>
          </p:cNvPr>
          <p:cNvSpPr txBox="1"/>
          <p:nvPr/>
        </p:nvSpPr>
        <p:spPr>
          <a:xfrm>
            <a:off x="3233729" y="2264787"/>
            <a:ext cx="314153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 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out</a:t>
            </a:r>
            <a:r>
              <a:rPr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IP, </a:t>
            </a:r>
            <a:r>
              <a:rPr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60</a:t>
            </a:r>
          </a:p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11.8 (8.9–14.7) months   </a:t>
            </a:r>
          </a:p>
          <a:p>
            <a:r>
              <a:rPr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IP, </a:t>
            </a:r>
            <a:r>
              <a:rPr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27</a:t>
            </a:r>
          </a:p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8.7 (0.4–17.0) months </a:t>
            </a:r>
          </a:p>
        </p:txBody>
      </p:sp>
      <p:cxnSp>
        <p:nvCxnSpPr>
          <p:cNvPr id="6" name="直線コネクタ 5"/>
          <p:cNvCxnSpPr>
            <a:cxnSpLocks/>
          </p:cNvCxnSpPr>
          <p:nvPr/>
        </p:nvCxnSpPr>
        <p:spPr>
          <a:xfrm>
            <a:off x="3233729" y="2997939"/>
            <a:ext cx="282257" cy="0"/>
          </a:xfrm>
          <a:prstGeom prst="line">
            <a:avLst/>
          </a:prstGeom>
          <a:ln w="381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線コネクタ 6"/>
          <p:cNvCxnSpPr>
            <a:cxnSpLocks/>
          </p:cNvCxnSpPr>
          <p:nvPr/>
        </p:nvCxnSpPr>
        <p:spPr>
          <a:xfrm>
            <a:off x="3233729" y="2445837"/>
            <a:ext cx="282257" cy="0"/>
          </a:xfrm>
          <a:prstGeom prst="line">
            <a:avLst/>
          </a:prstGeom>
          <a:ln w="38100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6C896295-C36F-4309-A9FC-1F7BFE8101A7}"/>
              </a:ext>
            </a:extLst>
          </p:cNvPr>
          <p:cNvSpPr txBox="1"/>
          <p:nvPr/>
        </p:nvSpPr>
        <p:spPr>
          <a:xfrm>
            <a:off x="698534" y="5540110"/>
            <a:ext cx="12979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  </a:t>
            </a:r>
            <a:r>
              <a:rPr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93</a:t>
            </a: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5933776" y="6012981"/>
            <a:ext cx="615121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/>
              <a:t>No. at Risk </a:t>
            </a:r>
          </a:p>
          <a:p>
            <a:r>
              <a:rPr lang="en-US" altLang="ja-JP" sz="1200" dirty="0"/>
              <a:t>Without IP     69                  45                    23                     9                    3                    1                     0        </a:t>
            </a:r>
          </a:p>
          <a:p>
            <a:r>
              <a:rPr lang="en-US" altLang="ja-JP" sz="1200" dirty="0"/>
              <a:t>With IP             4                     2                      0                     0                    0                    0                     0</a:t>
            </a:r>
            <a:endParaRPr lang="en-US" altLang="ja-JP" sz="1400" dirty="0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3056A13C-3A85-49CE-8B90-A5B9DAB3974C}"/>
              </a:ext>
            </a:extLst>
          </p:cNvPr>
          <p:cNvSpPr txBox="1"/>
          <p:nvPr/>
        </p:nvSpPr>
        <p:spPr>
          <a:xfrm>
            <a:off x="8943452" y="2264787"/>
            <a:ext cx="314153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 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out</a:t>
            </a:r>
            <a:r>
              <a:rPr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IP, </a:t>
            </a:r>
            <a:r>
              <a:rPr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69</a:t>
            </a:r>
          </a:p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7.6 (5.3–9.9) months   </a:t>
            </a:r>
          </a:p>
          <a:p>
            <a:r>
              <a:rPr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IP, </a:t>
            </a:r>
            <a:r>
              <a:rPr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4</a:t>
            </a:r>
          </a:p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      5.1 (0.0–10.6) months </a:t>
            </a: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6C896295-C36F-4309-A9FC-1F7BFE8101A7}"/>
              </a:ext>
            </a:extLst>
          </p:cNvPr>
          <p:cNvSpPr txBox="1"/>
          <p:nvPr/>
        </p:nvSpPr>
        <p:spPr>
          <a:xfrm>
            <a:off x="6703236" y="5540110"/>
            <a:ext cx="12979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　  </a:t>
            </a:r>
            <a:r>
              <a:rPr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36</a:t>
            </a:r>
          </a:p>
        </p:txBody>
      </p: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58D1EB82-0F93-4C3E-84A1-B4F1CAC0E422}"/>
              </a:ext>
            </a:extLst>
          </p:cNvPr>
          <p:cNvSpPr/>
          <p:nvPr/>
        </p:nvSpPr>
        <p:spPr>
          <a:xfrm>
            <a:off x="698534" y="1617164"/>
            <a:ext cx="529045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OS (months) </a:t>
            </a:r>
            <a:endParaRPr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正方形/長方形 17">
            <a:extLst>
              <a:ext uri="{FF2B5EF4-FFF2-40B4-BE49-F238E27FC236}">
                <a16:creationId xmlns:a16="http://schemas.microsoft.com/office/drawing/2014/main" id="{58D1EB82-0F93-4C3E-84A1-B4F1CAC0E422}"/>
              </a:ext>
            </a:extLst>
          </p:cNvPr>
          <p:cNvSpPr/>
          <p:nvPr/>
        </p:nvSpPr>
        <p:spPr>
          <a:xfrm>
            <a:off x="6689759" y="1621613"/>
            <a:ext cx="529045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OS (months) </a:t>
            </a:r>
            <a:endParaRPr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0052388B-7F28-4AA5-8E49-59B139FCF86B}"/>
              </a:ext>
            </a:extLst>
          </p:cNvPr>
          <p:cNvSpPr txBox="1"/>
          <p:nvPr/>
        </p:nvSpPr>
        <p:spPr>
          <a:xfrm>
            <a:off x="887015" y="861548"/>
            <a:ext cx="371513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</a:t>
            </a:r>
            <a:r>
              <a:rPr lang="ja-JP" alt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1-a</a:t>
            </a:r>
            <a:endParaRPr lang="ja-JP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5DCF4878-830C-49D6-8984-67AB02089CCF}"/>
              </a:ext>
            </a:extLst>
          </p:cNvPr>
          <p:cNvSpPr txBox="1"/>
          <p:nvPr/>
        </p:nvSpPr>
        <p:spPr>
          <a:xfrm>
            <a:off x="341092" y="149004"/>
            <a:ext cx="428989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</a:t>
            </a:r>
            <a:r>
              <a:rPr lang="ja-JP" alt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1</a:t>
            </a:r>
            <a:endParaRPr lang="ja-JP" altLang="en-US" sz="2000" b="1" dirty="0">
              <a:highlight>
                <a:srgbClr val="FFFF00"/>
              </a:highligh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9D8656D4-487A-4166-A7BA-31CBE615D4AB}"/>
              </a:ext>
            </a:extLst>
          </p:cNvPr>
          <p:cNvSpPr txBox="1"/>
          <p:nvPr/>
        </p:nvSpPr>
        <p:spPr>
          <a:xfrm>
            <a:off x="7018199" y="863224"/>
            <a:ext cx="371513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1-b</a:t>
            </a:r>
            <a:endParaRPr lang="ja-JP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06759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96</TotalTime>
  <Words>74</Words>
  <Application>Microsoft Office PowerPoint</Application>
  <PresentationFormat>ワイド画面</PresentationFormat>
  <Paragraphs>22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呼吸器内科外来CRDr</dc:creator>
  <cp:lastModifiedBy>昌之 白澤</cp:lastModifiedBy>
  <cp:revision>101</cp:revision>
  <dcterms:created xsi:type="dcterms:W3CDTF">2017-10-31T12:42:28Z</dcterms:created>
  <dcterms:modified xsi:type="dcterms:W3CDTF">2019-02-03T04:40:30Z</dcterms:modified>
</cp:coreProperties>
</file>